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18C8E6-85C7-824D-9B9E-993887F8E1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52827E8-5E19-3F4B-B584-C0EE41B4D1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623A79-FFDC-6442-98FB-F1B7814B7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DC1755-393F-8E49-97F8-0DFE8B12E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A02C8B-2FBD-CA4D-99C0-519E16DC8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068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390D17-07B5-D247-A222-0E46324867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5AC7DC-D189-054E-B3C2-60EB8F7BE8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1B1E98-FB20-4B43-8534-EA853A0BAF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9C2706-971F-0946-98AA-586A334C1E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940E6C-525D-414A-9F11-71E51241F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7078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BE47F1-D613-8F4F-B5EF-128D195072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E96B8C-8A18-3144-B183-2D96213E16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A04544-3FC1-5442-A077-D69C3360C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6BA65F-1E81-E945-A7E2-270DECC44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F01467-8D6A-6647-B519-63BBD18F0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655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051437-87D3-5C4D-A4D7-43E5C980CE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F3F322-CD4A-F148-843F-AB6769FF37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9DAF54-690A-D446-B014-86506AADD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97FC7C-F3B6-3841-A997-6BAD582B5F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2F37F5-A775-0D4F-8B5C-3309BFF45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85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7E6AAC-E822-1943-9C10-266F4FE1B9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C9CA4E-7C47-7649-83F4-762D689AF5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CD15E5-7FE4-3A43-8E71-0363F9F1F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C30704-7271-2146-9172-4D446C053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1564C5-BE2D-B942-BCC1-D074D9428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235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A5ED54-35B4-7240-9A0C-7090C99EA2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5593EC-455D-694D-948E-8C88EE74EC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E9B238-680F-784E-8690-2010F5858B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5AA47A-5FA0-F346-863C-84BC785DE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562F63-1DA1-4743-8B72-7C1FD892B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2ED68D-3B72-FC43-8768-3E344AB2F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803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B2C2C-7920-4549-A3DD-042AD88AE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249B52-85FD-AF4C-92F1-854CE07ED5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A51027-16AB-BB4A-8A78-4643285CBE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C511E4-922B-6D47-B780-934ECBA8EF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F7A2CD-7945-E74C-91EB-FCDF95C268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64CCBB-269C-C247-B90C-E72FF4FD8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458890-09AC-3D41-8B00-DE00E05E4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FFE4531-8CBA-754B-B248-6FF4A47F73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947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5DD469-1B71-BF4D-B5F0-0263BEFECD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38D6C5-0D4C-8F49-AA39-C080F1382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291453F-828F-0D43-BF37-C9D6B15A6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4CA20D-2710-A644-98DB-C9E099F39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324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3479B4-C1CE-2344-8256-7D4845562E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3389C8-7D5C-254A-A57B-196AD119F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88C721-EEE8-5944-B6F2-B18540627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953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E9BD48-D3E0-5142-85E7-D8C8567BBD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7D0C63-C770-0C4E-95F2-6C987D136B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620FE4-BAF5-4345-A9EA-C7682263A9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7ACF7A-9B86-D446-88A4-AEEEAC7FA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D8491F-A37B-A341-9690-596845128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E44CE7-9B21-9E42-95BA-7AAEAF898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923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F7693-B865-7F4E-BC3A-7C87A317F6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5FC8EE-FD21-9940-8BBA-C82BCC073C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DC4E7A-CEBB-C24C-BF31-D160BB4403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E3C016-39D0-3242-9E4F-F8ED8FB71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B4F4AB-C3EB-4640-9103-582EBE789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D712E4-F937-F84F-BBD2-9E59B6100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202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A394B1B-59BB-9B4D-A2F9-C69DE34844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F9F31E-AA0F-424F-ABE8-643694C3DB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D69FE-3102-334F-A44F-4D3664D92A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E9E8E-3E60-7A4F-A46D-80ED35074EC9}" type="datetimeFigureOut">
              <a:rPr lang="en-US" smtClean="0"/>
              <a:t>12/2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7D8066-2949-BF43-82F7-EC03C5D2E8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47006F-F8DA-454B-B8F4-5C44BA6D71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592E91-7A5C-A046-998B-5BBEDC0B9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433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mailto:trkelly@ucdavis.edu" TargetMode="External"/><Relationship Id="rId3" Type="http://schemas.openxmlformats.org/officeDocument/2006/relationships/hyperlink" Target="mailto:ucywang@ucdavis.edu" TargetMode="External"/><Relationship Id="rId7" Type="http://schemas.openxmlformats.org/officeDocument/2006/relationships/hyperlink" Target="mailto:jdekkers@iastate.edu" TargetMode="External"/><Relationship Id="rId2" Type="http://schemas.openxmlformats.org/officeDocument/2006/relationships/hyperlink" Target="mailto:hzhou@ucdavis.edu" TargetMode="External"/><Relationship Id="rId1" Type="http://schemas.openxmlformats.org/officeDocument/2006/relationships/slideLayout" Target="../slideLayouts/slideLayout2.xml"/><Relationship Id="rId6" Type="http://schemas.openxmlformats.org/officeDocument/2006/relationships/hyperlink" Target="mailto:sjlamont@iastate.edu" TargetMode="External"/><Relationship Id="rId5" Type="http://schemas.openxmlformats.org/officeDocument/2006/relationships/hyperlink" Target="mailto:ragallardo@ucdavis.edu" TargetMode="External"/><Relationship Id="rId4" Type="http://schemas.openxmlformats.org/officeDocument/2006/relationships/hyperlink" Target="mailto:kchantha@ucdavis.edu" TargetMode="Externa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03C318-5DF5-EC48-A8AB-4D459DD397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55000" lnSpcReduction="20000"/>
          </a:bodyPr>
          <a:lstStyle/>
          <a:p>
            <a:pPr marL="0" indent="0">
              <a:buNone/>
            </a:pPr>
            <a:r>
              <a:rPr lang="en-US" b="1" dirty="0"/>
              <a:t>Title: Distinct transcriptomic response to Newcastle disease virus infection during heat stress in chicken tracheal epithelial tissue.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Perot Saelao</a:t>
            </a:r>
            <a:r>
              <a:rPr lang="en-US" baseline="30000" dirty="0"/>
              <a:t>1,2,3</a:t>
            </a:r>
            <a:r>
              <a:rPr lang="en-US" dirty="0"/>
              <a:t>, Ying Wang</a:t>
            </a:r>
            <a:r>
              <a:rPr lang="en-US" baseline="30000" dirty="0"/>
              <a:t>2,3</a:t>
            </a:r>
            <a:r>
              <a:rPr lang="en-US" dirty="0"/>
              <a:t>, </a:t>
            </a:r>
            <a:r>
              <a:rPr lang="en-US" dirty="0" err="1"/>
              <a:t>Ganrea</a:t>
            </a:r>
            <a:r>
              <a:rPr lang="en-US" dirty="0"/>
              <a:t> Chanthavixay</a:t>
            </a:r>
            <a:r>
              <a:rPr lang="en-US" baseline="30000" dirty="0"/>
              <a:t>2,3</a:t>
            </a:r>
            <a:r>
              <a:rPr lang="en-US" dirty="0"/>
              <a:t>, Vivian Yu</a:t>
            </a:r>
            <a:r>
              <a:rPr lang="en-US" baseline="30000" dirty="0"/>
              <a:t>3</a:t>
            </a:r>
            <a:r>
              <a:rPr lang="en-US" dirty="0"/>
              <a:t>, Rodrigo A. Gallardo</a:t>
            </a:r>
            <a:r>
              <a:rPr lang="en-US" baseline="30000" dirty="0"/>
              <a:t>2,4</a:t>
            </a:r>
            <a:r>
              <a:rPr lang="en-US" dirty="0"/>
              <a:t>, Jack C. M. Dekkers</a:t>
            </a:r>
            <a:r>
              <a:rPr lang="en-US" baseline="30000" dirty="0"/>
              <a:t>2,5</a:t>
            </a:r>
            <a:r>
              <a:rPr lang="en-US" dirty="0"/>
              <a:t>, Susan J. Lamont</a:t>
            </a:r>
            <a:r>
              <a:rPr lang="en-US" baseline="30000" dirty="0"/>
              <a:t>2,5</a:t>
            </a:r>
            <a:r>
              <a:rPr lang="en-US" dirty="0"/>
              <a:t>, Terra Kelly</a:t>
            </a:r>
            <a:r>
              <a:rPr lang="en-US" baseline="30000" dirty="0"/>
              <a:t>2,4</a:t>
            </a:r>
            <a:r>
              <a:rPr lang="en-US" dirty="0"/>
              <a:t>, and </a:t>
            </a:r>
            <a:r>
              <a:rPr lang="en-US" dirty="0" err="1"/>
              <a:t>Huaijun</a:t>
            </a:r>
            <a:r>
              <a:rPr lang="en-US" dirty="0"/>
              <a:t> Zhou</a:t>
            </a:r>
            <a:r>
              <a:rPr lang="en-US" baseline="30000" dirty="0"/>
              <a:t>2,3*</a:t>
            </a:r>
            <a:endParaRPr lang="en-US" dirty="0"/>
          </a:p>
          <a:p>
            <a:pPr marL="0" indent="0">
              <a:buNone/>
            </a:pPr>
            <a:r>
              <a:rPr lang="en-US" b="1" dirty="0"/>
              <a:t> </a:t>
            </a:r>
            <a:endParaRPr lang="en-US" dirty="0"/>
          </a:p>
          <a:p>
            <a:pPr marL="0" indent="0">
              <a:buNone/>
            </a:pPr>
            <a:r>
              <a:rPr lang="en-US" b="1" dirty="0"/>
              <a:t> 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 </a:t>
            </a:r>
          </a:p>
          <a:p>
            <a:pPr marL="0" indent="0">
              <a:buNone/>
            </a:pPr>
            <a:r>
              <a:rPr lang="en-US" baseline="30000" dirty="0"/>
              <a:t>1</a:t>
            </a:r>
            <a:r>
              <a:rPr lang="en-US" dirty="0"/>
              <a:t>Integrative Genetics and Genomics Graduate Group, University of California, Davis, CA 95616, USA</a:t>
            </a:r>
          </a:p>
          <a:p>
            <a:pPr marL="0" indent="0">
              <a:buNone/>
            </a:pPr>
            <a:r>
              <a:rPr lang="en-US" baseline="30000" dirty="0"/>
              <a:t>2</a:t>
            </a:r>
            <a:r>
              <a:rPr lang="en-US" dirty="0"/>
              <a:t>Feed the Future Innovation Lab for Genomics to Improve Poultry, University of California, Davis, CA 95616, USA</a:t>
            </a:r>
          </a:p>
          <a:p>
            <a:pPr marL="0" indent="0">
              <a:buNone/>
            </a:pPr>
            <a:r>
              <a:rPr lang="en-US" baseline="30000" dirty="0"/>
              <a:t>3</a:t>
            </a:r>
            <a:r>
              <a:rPr lang="en-US" dirty="0"/>
              <a:t>Department of Animal Science, University of California, Davis, CA 95616, USA</a:t>
            </a:r>
          </a:p>
          <a:p>
            <a:pPr marL="0" indent="0">
              <a:buNone/>
            </a:pPr>
            <a:r>
              <a:rPr lang="en-US" baseline="30000" dirty="0"/>
              <a:t>4</a:t>
            </a:r>
            <a:r>
              <a:rPr lang="en-US" dirty="0"/>
              <a:t>School of Veterinary Medicine, University of California, Davis, CA 95616, USA </a:t>
            </a:r>
          </a:p>
          <a:p>
            <a:pPr marL="0" indent="0">
              <a:buNone/>
            </a:pPr>
            <a:r>
              <a:rPr lang="en-US" baseline="30000" dirty="0"/>
              <a:t>5</a:t>
            </a:r>
            <a:r>
              <a:rPr lang="en-US" dirty="0"/>
              <a:t>Department of Animal Science, Iowa State University, Ames, IA 50011, USA</a:t>
            </a:r>
          </a:p>
          <a:p>
            <a:pPr marL="0" indent="0">
              <a:buNone/>
            </a:pPr>
            <a:r>
              <a:rPr lang="en-US" baseline="30000" dirty="0"/>
              <a:t> </a:t>
            </a:r>
            <a:endParaRPr lang="en-US" dirty="0"/>
          </a:p>
          <a:p>
            <a:pPr marL="0" indent="0">
              <a:buNone/>
            </a:pPr>
            <a:r>
              <a:rPr lang="en-US" baseline="30000" dirty="0"/>
              <a:t>*</a:t>
            </a:r>
            <a:r>
              <a:rPr lang="en-US" dirty="0"/>
              <a:t>Corresponding author: </a:t>
            </a:r>
            <a:r>
              <a:rPr lang="en-US" dirty="0">
                <a:hlinkClick r:id="rId2"/>
              </a:rPr>
              <a:t>hzhou@ucdavis.edu</a:t>
            </a:r>
            <a:r>
              <a:rPr lang="en-US" dirty="0"/>
              <a:t> 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email addresses in author order: </a:t>
            </a:r>
            <a:r>
              <a:rPr lang="en-US" dirty="0" err="1"/>
              <a:t>psaelao@ucdavis.edu</a:t>
            </a:r>
            <a:r>
              <a:rPr lang="en-US" dirty="0"/>
              <a:t>, </a:t>
            </a:r>
            <a:r>
              <a:rPr lang="en-US" u="sng" dirty="0">
                <a:hlinkClick r:id="rId3"/>
              </a:rPr>
              <a:t>ucywang@ucdavis.edu</a:t>
            </a:r>
            <a:r>
              <a:rPr lang="en-US" dirty="0"/>
              <a:t>, </a:t>
            </a:r>
            <a:r>
              <a:rPr lang="en-US" u="sng" dirty="0">
                <a:hlinkClick r:id="rId4"/>
              </a:rPr>
              <a:t>kchantha@ucdavis.edu</a:t>
            </a:r>
            <a:r>
              <a:rPr lang="en-US" dirty="0"/>
              <a:t>, </a:t>
            </a:r>
            <a:r>
              <a:rPr lang="en-US" dirty="0" err="1"/>
              <a:t>vsyu@ucdavis.edu</a:t>
            </a:r>
            <a:r>
              <a:rPr lang="en-US" dirty="0"/>
              <a:t>, </a:t>
            </a:r>
            <a:r>
              <a:rPr lang="en-US" u="sng" dirty="0">
                <a:hlinkClick r:id="rId5"/>
              </a:rPr>
              <a:t>ragallardo@ucdavis.edu</a:t>
            </a:r>
            <a:r>
              <a:rPr lang="en-US" u="sng" dirty="0"/>
              <a:t>, </a:t>
            </a:r>
            <a:r>
              <a:rPr lang="en-US" dirty="0"/>
              <a:t> </a:t>
            </a:r>
            <a:r>
              <a:rPr lang="en-US" u="sng" dirty="0">
                <a:hlinkClick r:id="rId6"/>
              </a:rPr>
              <a:t>sjlamont@iastate.edu</a:t>
            </a:r>
            <a:r>
              <a:rPr lang="en-US" u="sng" dirty="0"/>
              <a:t>, </a:t>
            </a:r>
            <a:r>
              <a:rPr lang="en-US" u="sng" dirty="0">
                <a:hlinkClick r:id="rId7"/>
              </a:rPr>
              <a:t>jdekkers@iastate.edu</a:t>
            </a:r>
            <a:r>
              <a:rPr lang="en-US" u="sng" dirty="0"/>
              <a:t>, </a:t>
            </a:r>
            <a:r>
              <a:rPr lang="en-US" u="sng" dirty="0">
                <a:hlinkClick r:id="rId8"/>
              </a:rPr>
              <a:t>trkelly@ucdavis.edu</a:t>
            </a:r>
            <a:r>
              <a:rPr lang="en-US" u="sng" dirty="0"/>
              <a:t>, </a:t>
            </a:r>
            <a:r>
              <a:rPr lang="en-US" u="sng" dirty="0">
                <a:hlinkClick r:id="rId2"/>
              </a:rPr>
              <a:t>hzhou@ucdavis.edu</a:t>
            </a: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34392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1844C76-D1D1-DE4C-9F62-405B838F81C7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5" b="-1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6314644-9AA1-D343-AEC2-03C86E8E6558}"/>
              </a:ext>
            </a:extLst>
          </p:cNvPr>
          <p:cNvSpPr txBox="1"/>
          <p:nvPr/>
        </p:nvSpPr>
        <p:spPr>
          <a:xfrm>
            <a:off x="924339" y="477078"/>
            <a:ext cx="1252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1S</a:t>
            </a:r>
          </a:p>
        </p:txBody>
      </p:sp>
    </p:spTree>
    <p:extLst>
      <p:ext uri="{BB962C8B-B14F-4D97-AF65-F5344CB8AC3E}">
        <p14:creationId xmlns:p14="http://schemas.microsoft.com/office/powerpoint/2010/main" val="36465945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7D9E6E1A-D6FF-9B43-A8DB-84D0618EBD53}"/>
              </a:ext>
            </a:extLst>
          </p:cNvPr>
          <p:cNvPicPr>
            <a:picLocks noGrp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00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1EC0629-B3B3-D04A-AE2F-95DD0793CE6C}"/>
              </a:ext>
            </a:extLst>
          </p:cNvPr>
          <p:cNvSpPr txBox="1"/>
          <p:nvPr/>
        </p:nvSpPr>
        <p:spPr>
          <a:xfrm>
            <a:off x="457200" y="139148"/>
            <a:ext cx="1321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491111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14</Words>
  <Application>Microsoft Macintosh PowerPoint</Application>
  <PresentationFormat>Widescreen</PresentationFormat>
  <Paragraphs>1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elao, Perot - ARS</dc:creator>
  <cp:lastModifiedBy>Saelao, Perot - ARS</cp:lastModifiedBy>
  <cp:revision>3</cp:revision>
  <dcterms:created xsi:type="dcterms:W3CDTF">2020-10-27T18:21:16Z</dcterms:created>
  <dcterms:modified xsi:type="dcterms:W3CDTF">2020-12-22T13:13:14Z</dcterms:modified>
</cp:coreProperties>
</file>